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319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7" autoAdjust="0"/>
    <p:restoredTop sz="94660"/>
  </p:normalViewPr>
  <p:slideViewPr>
    <p:cSldViewPr snapToGrid="0">
      <p:cViewPr varScale="1">
        <p:scale>
          <a:sx n="89" d="100"/>
          <a:sy n="89" d="100"/>
        </p:scale>
        <p:origin x="558" y="45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5317675-F945-4BC9-A042-032FA7756A59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F5E5324A-9C28-4D00-8B94-711E5722891D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CC42B9D-0381-4153-8292-E6E10727A6C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9DD849-6857-4560-8D4B-56C287C861E7}" type="datetimeFigureOut">
              <a:rPr lang="en-US" smtClean="0"/>
              <a:t>3/24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609F560-CB66-44FF-A40F-FD8DFC98CDB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9C14C7D-BB03-44A1-84BB-BFFEDFED287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71A6AB-08BD-49E8-B4B8-DE8F1B5BBAC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1374398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C89C3CB-B5AE-417D-841B-6A62E9CBBFA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F6077388-2EC0-48CA-84F7-9E976330A35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EAC4F3C-03EC-4B3D-8E87-A979712F44D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9DD849-6857-4560-8D4B-56C287C861E7}" type="datetimeFigureOut">
              <a:rPr lang="en-US" smtClean="0"/>
              <a:t>3/24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E687FC1-0BFF-4250-851F-66FA3E517A0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146CF4D-762F-4C44-82BD-0C67A79D9FB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71A6AB-08BD-49E8-B4B8-DE8F1B5BBAC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091942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74BA5C4D-E23E-404D-BAED-75C027538BD7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21B4300E-75D2-45C8-9244-F0A8FFB3AD0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FB93585-AB73-4EEC-AE57-127FF4A78AA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9DD849-6857-4560-8D4B-56C287C861E7}" type="datetimeFigureOut">
              <a:rPr lang="en-US" smtClean="0"/>
              <a:t>3/24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1F57858-00A3-46AD-8A37-84E807E62A1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E3C35B6-18FA-406A-9A22-22C73281408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71A6AB-08BD-49E8-B4B8-DE8F1B5BBAC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8631238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20375B1-6E12-412E-BB0A-AE6254F0DAD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0057CC6-F458-438B-A128-922B086F2E43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D261E06-7F99-4C09-9125-2383A833009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9DD849-6857-4560-8D4B-56C287C861E7}" type="datetimeFigureOut">
              <a:rPr lang="en-US" smtClean="0"/>
              <a:t>3/24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AA6E32D-8D3C-4F1E-B27E-01CE8C22DE3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D5936B5-A9E1-4118-B1E6-1BEFD7436C7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71A6AB-08BD-49E8-B4B8-DE8F1B5BBAC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3623372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78D0062-B73E-4054-BD76-78ACD1F0FF3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9DDDC06-80CD-4030-A722-9EEC2AC9DD3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8F8AC13-07F3-4D0A-8379-D356D40D7A2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9DD849-6857-4560-8D4B-56C287C861E7}" type="datetimeFigureOut">
              <a:rPr lang="en-US" smtClean="0"/>
              <a:t>3/24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7F867AD-CEB1-4EFD-9EF9-9904851BA70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49E6301-020D-474B-ADD0-80D59551FD4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71A6AB-08BD-49E8-B4B8-DE8F1B5BBAC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4701218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07430F4-D3FE-45A7-9862-FC608B98C93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18F3A3A-8D7D-4539-9D12-8E2DC20C31CF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8CB8EA7B-FFB1-4787-AE92-EA1E4CF5EDF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DCDBA67-3587-4F22-867A-94DF1AD5698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9DD849-6857-4560-8D4B-56C287C861E7}" type="datetimeFigureOut">
              <a:rPr lang="en-US" smtClean="0"/>
              <a:t>3/24/20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A967326-5E67-418C-AFAB-AC4DEDACC2D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6C23426-0AB0-4CA7-A6F6-A7715912D77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71A6AB-08BD-49E8-B4B8-DE8F1B5BBAC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8819790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38A6F83-07D7-4EB9-B53B-87963A5F30A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DF03313-BF23-4D51-B81C-C5B5104E9B7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6A04ACE4-AB46-44A9-A47F-4B63AA5E4AF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4F0AF1D3-BF4E-4480-80E9-D0C30E8AA5BE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7555E75C-35F3-4C89-94A5-77136257CCE8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0C9F3FBE-213C-47E3-A353-D540D21875F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9DD849-6857-4560-8D4B-56C287C861E7}" type="datetimeFigureOut">
              <a:rPr lang="en-US" smtClean="0"/>
              <a:t>3/24/2021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1F5C4B10-D4C0-4CA1-B7A5-9FA4D082FD0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94BCA6F6-729D-431C-998E-C1188A4FB02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71A6AB-08BD-49E8-B4B8-DE8F1B5BBAC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7779516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B0F57E5-6C16-4AA8-9D4A-8BFE5622AE5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DC7D272B-5952-4A22-9265-739196290AC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9DD849-6857-4560-8D4B-56C287C861E7}" type="datetimeFigureOut">
              <a:rPr lang="en-US" smtClean="0"/>
              <a:t>3/24/2021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A3CA1F00-0956-4A23-BD25-C95B16A84D6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D43EF7B9-80C4-4165-A945-CA1E4ADBC48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71A6AB-08BD-49E8-B4B8-DE8F1B5BBAC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877942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66AFB91C-55A0-48BE-9FAF-E6D3252026E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9DD849-6857-4560-8D4B-56C287C861E7}" type="datetimeFigureOut">
              <a:rPr lang="en-US" smtClean="0"/>
              <a:t>3/24/2021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84B485B6-D8EB-4AA7-BCCE-F7A057D11C4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41BD8AF5-FAAE-48AF-8F97-A766C17CEE9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71A6AB-08BD-49E8-B4B8-DE8F1B5BBAC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3451575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737F793-5F4F-4413-A5C3-935143E438D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4DC7FD7-039B-44EA-BCEF-1FFF9AE8642B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96B61E08-4886-4B6C-BF3A-177B14586DE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501859E-E9D9-4BCE-8433-40EEAD3415D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9DD849-6857-4560-8D4B-56C287C861E7}" type="datetimeFigureOut">
              <a:rPr lang="en-US" smtClean="0"/>
              <a:t>3/24/20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8850793F-E3BC-4169-AEF9-F811A2B2B1C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AAF2C952-3114-4FCA-A6FE-77811AABDF5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71A6AB-08BD-49E8-B4B8-DE8F1B5BBAC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0544908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B37E87E-3EAD-4F5F-8AD5-2E68458640F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F0874713-8977-41E6-BBAE-975BB392D5F4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ACAB0507-69B6-4E33-AD2D-2CAE5991AD0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8C6A364-B7B8-4B62-877C-573EF1CE18C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9DD849-6857-4560-8D4B-56C287C861E7}" type="datetimeFigureOut">
              <a:rPr lang="en-US" smtClean="0"/>
              <a:t>3/24/20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3654D79-8D75-4266-A82D-6B14B005908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714EB3D-DCDF-45DA-94CA-E0E6A9C3AE0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71A6AB-08BD-49E8-B4B8-DE8F1B5BBAC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277015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4B49A613-47E0-4733-B732-9911F273142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CE6C0E0-3675-4E0C-AF66-D5CC2C8A87B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6801367-DDE7-4860-9B20-68533A6D398C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B9DD849-6857-4560-8D4B-56C287C861E7}" type="datetimeFigureOut">
              <a:rPr lang="en-US" smtClean="0"/>
              <a:t>3/24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5976512-D3D7-4CF5-BC1F-FFAA70ACB39B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6DEF2C4-6A2C-4EA7-9896-B0C8093A18DC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F71A6AB-08BD-49E8-B4B8-DE8F1B5BBAC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7935054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DA8A95DA-F462-4CA1-9110-E0DE3DFD1C15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47136" t="38788" r="23864" b="36861"/>
          <a:stretch/>
        </p:blipFill>
        <p:spPr>
          <a:xfrm>
            <a:off x="6323214" y="1972622"/>
            <a:ext cx="5714768" cy="2699267"/>
          </a:xfrm>
          <a:prstGeom prst="rect">
            <a:avLst/>
          </a:prstGeom>
        </p:spPr>
      </p:pic>
      <p:sp>
        <p:nvSpPr>
          <p:cNvPr id="4" name="Title 1">
            <a:extLst>
              <a:ext uri="{FF2B5EF4-FFF2-40B4-BE49-F238E27FC236}">
                <a16:creationId xmlns:a16="http://schemas.microsoft.com/office/drawing/2014/main" id="{C4E54062-A9D2-40AB-ADE9-B13CCDC3C7AE}"/>
              </a:ext>
            </a:extLst>
          </p:cNvPr>
          <p:cNvSpPr txBox="1">
            <a:spLocks/>
          </p:cNvSpPr>
          <p:nvPr/>
        </p:nvSpPr>
        <p:spPr>
          <a:xfrm>
            <a:off x="7051489" y="1747682"/>
            <a:ext cx="3383335" cy="375236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ctr"/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Neurological Function Score Per Age Group</a:t>
            </a:r>
          </a:p>
        </p:txBody>
      </p:sp>
      <p:pic>
        <p:nvPicPr>
          <p:cNvPr id="6" name="Picture 5">
            <a:extLst>
              <a:ext uri="{FF2B5EF4-FFF2-40B4-BE49-F238E27FC236}">
                <a16:creationId xmlns:a16="http://schemas.microsoft.com/office/drawing/2014/main" id="{9944F12C-605D-44EB-A7AF-52036DAE2F69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45909" t="35959" r="20545" b="32283"/>
          <a:stretch/>
        </p:blipFill>
        <p:spPr>
          <a:xfrm>
            <a:off x="540326" y="1972622"/>
            <a:ext cx="4871260" cy="2594045"/>
          </a:xfrm>
          <a:prstGeom prst="rect">
            <a:avLst/>
          </a:prstGeom>
        </p:spPr>
      </p:pic>
      <p:sp>
        <p:nvSpPr>
          <p:cNvPr id="7" name="Title 1">
            <a:extLst>
              <a:ext uri="{FF2B5EF4-FFF2-40B4-BE49-F238E27FC236}">
                <a16:creationId xmlns:a16="http://schemas.microsoft.com/office/drawing/2014/main" id="{68A5BC73-545F-458C-B2C4-E242F4EB8ED1}"/>
              </a:ext>
            </a:extLst>
          </p:cNvPr>
          <p:cNvSpPr txBox="1">
            <a:spLocks/>
          </p:cNvSpPr>
          <p:nvPr/>
        </p:nvSpPr>
        <p:spPr>
          <a:xfrm>
            <a:off x="936247" y="1747682"/>
            <a:ext cx="3383335" cy="375236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ctr"/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Survival Per Age Group</a:t>
            </a:r>
          </a:p>
        </p:txBody>
      </p:sp>
      <p:sp>
        <p:nvSpPr>
          <p:cNvPr id="8" name="Title 1">
            <a:extLst>
              <a:ext uri="{FF2B5EF4-FFF2-40B4-BE49-F238E27FC236}">
                <a16:creationId xmlns:a16="http://schemas.microsoft.com/office/drawing/2014/main" id="{54CCF77B-FB9F-4DDB-84F2-6E3DC75DE180}"/>
              </a:ext>
            </a:extLst>
          </p:cNvPr>
          <p:cNvSpPr txBox="1">
            <a:spLocks/>
          </p:cNvSpPr>
          <p:nvPr/>
        </p:nvSpPr>
        <p:spPr>
          <a:xfrm>
            <a:off x="57907" y="52226"/>
            <a:ext cx="10332663" cy="397379"/>
          </a:xfrm>
          <a:prstGeom prst="rect">
            <a:avLst/>
          </a:prstGeom>
        </p:spPr>
        <p:txBody>
          <a:bodyPr>
            <a:no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1800" dirty="0">
                <a:latin typeface="Arial" panose="020B0604020202020204" pitchFamily="34" charset="0"/>
                <a:cs typeface="Arial" panose="020B0604020202020204" pitchFamily="34" charset="0"/>
              </a:rPr>
              <a:t>Supplemental </a:t>
            </a:r>
            <a:r>
              <a:rPr lang="en-US" sz="1800">
                <a:latin typeface="Arial" panose="020B0604020202020204" pitchFamily="34" charset="0"/>
                <a:cs typeface="Arial" panose="020B0604020202020204" pitchFamily="34" charset="0"/>
              </a:rPr>
              <a:t>Figure 2: </a:t>
            </a:r>
            <a:r>
              <a:rPr lang="en-US" sz="1800" dirty="0">
                <a:latin typeface="Arial" panose="020B0604020202020204" pitchFamily="34" charset="0"/>
                <a:cs typeface="Arial" panose="020B0604020202020204" pitchFamily="34" charset="0"/>
              </a:rPr>
              <a:t>Characteristics of Cardiac Arrest Mice – Age Differences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092015D5-C1C8-4B66-94BA-2B519BBE92E8}"/>
              </a:ext>
            </a:extLst>
          </p:cNvPr>
          <p:cNvSpPr txBox="1"/>
          <p:nvPr/>
        </p:nvSpPr>
        <p:spPr>
          <a:xfrm>
            <a:off x="6370534" y="1662585"/>
            <a:ext cx="281703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800" b="1" dirty="0"/>
              <a:t>B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04C6AE3C-8ED8-4069-A64E-DDB4E13A8932}"/>
              </a:ext>
            </a:extLst>
          </p:cNvPr>
          <p:cNvSpPr txBox="1"/>
          <p:nvPr/>
        </p:nvSpPr>
        <p:spPr>
          <a:xfrm>
            <a:off x="492342" y="1512956"/>
            <a:ext cx="281703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800" b="1" dirty="0"/>
              <a:t>A</a:t>
            </a:r>
          </a:p>
        </p:txBody>
      </p:sp>
    </p:spTree>
    <p:extLst>
      <p:ext uri="{BB962C8B-B14F-4D97-AF65-F5344CB8AC3E}">
        <p14:creationId xmlns:p14="http://schemas.microsoft.com/office/powerpoint/2010/main" val="101803419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</TotalTime>
  <Words>24</Words>
  <Application>Microsoft Office PowerPoint</Application>
  <PresentationFormat>Widescreen</PresentationFormat>
  <Paragraphs>5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laa Ousta</dc:creator>
  <cp:lastModifiedBy>Alaa Ousta</cp:lastModifiedBy>
  <cp:revision>11</cp:revision>
  <dcterms:created xsi:type="dcterms:W3CDTF">2020-12-10T21:33:06Z</dcterms:created>
  <dcterms:modified xsi:type="dcterms:W3CDTF">2021-03-24T15:03:03Z</dcterms:modified>
</cp:coreProperties>
</file>